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4" d="100"/>
          <a:sy n="64" d="100"/>
        </p:scale>
        <p:origin x="78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ekle Pauzaite" userId="06f7e524-8501-4f81-9b2a-484f6f2c7061" providerId="ADAL" clId="{E54163B5-263A-464A-8812-9DEBC385B07B}"/>
    <pc:docChg chg="addSld modSld">
      <pc:chgData name="Tekle Pauzaite" userId="06f7e524-8501-4f81-9b2a-484f6f2c7061" providerId="ADAL" clId="{E54163B5-263A-464A-8812-9DEBC385B07B}" dt="2024-03-27T11:05:27.834" v="80" actId="167"/>
      <pc:docMkLst>
        <pc:docMk/>
      </pc:docMkLst>
      <pc:sldChg chg="addSp delSp modSp add">
        <pc:chgData name="Tekle Pauzaite" userId="06f7e524-8501-4f81-9b2a-484f6f2c7061" providerId="ADAL" clId="{E54163B5-263A-464A-8812-9DEBC385B07B}" dt="2024-03-27T11:05:27.834" v="80" actId="167"/>
        <pc:sldMkLst>
          <pc:docMk/>
          <pc:sldMk cId="203325691" sldId="256"/>
        </pc:sldMkLst>
        <pc:spChg chg="del">
          <ac:chgData name="Tekle Pauzaite" userId="06f7e524-8501-4f81-9b2a-484f6f2c7061" providerId="ADAL" clId="{E54163B5-263A-464A-8812-9DEBC385B07B}" dt="2024-03-27T11:01:37.968" v="1"/>
          <ac:spMkLst>
            <pc:docMk/>
            <pc:sldMk cId="203325691" sldId="256"/>
            <ac:spMk id="2" creationId="{36C9B547-A587-4A9E-9B23-FCBAE0FC78D5}"/>
          </ac:spMkLst>
        </pc:spChg>
        <pc:spChg chg="del">
          <ac:chgData name="Tekle Pauzaite" userId="06f7e524-8501-4f81-9b2a-484f6f2c7061" providerId="ADAL" clId="{E54163B5-263A-464A-8812-9DEBC385B07B}" dt="2024-03-27T11:01:37.968" v="1"/>
          <ac:spMkLst>
            <pc:docMk/>
            <pc:sldMk cId="203325691" sldId="256"/>
            <ac:spMk id="3" creationId="{477EF715-CC93-4198-B609-6705B5ED45CE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4" creationId="{CCF0EF0D-E25D-4487-8800-374F393F33C1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5" creationId="{A101D58E-CCBB-48DC-A636-7F424B63A38B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6" creationId="{0490C55C-481F-4348-9403-EF1E7C0A342E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7" creationId="{DEDED5FA-3F8E-45EC-A470-F020DA8E223B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8" creationId="{D058E431-945F-4905-A8A2-7DDABE241F4C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9" creationId="{9CF5EA6D-711E-469B-AB79-9102F31E32FE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11" creationId="{97C678FE-5424-4E4E-8689-2AF6DF4CDF58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13" creationId="{93A81E34-BBC7-4428-8BAA-08294754CAAD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14" creationId="{C4C33F19-1077-4DF4-87FA-BB1BC398C29D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15" creationId="{1FD3B7D5-C3F9-46AF-BBCB-E85CF5CA2B94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16" creationId="{ED476953-3325-4C31-BA97-6CB78A54874A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17" creationId="{A3DB05F2-B61F-4599-A112-D5F6CD791DC3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18" creationId="{1C67FE52-BD2D-49A9-9A6B-E82774EC008A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19" creationId="{1DE82CF0-7027-491F-B297-C5AA1390ECAC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20" creationId="{533B0EC6-2476-43FF-829E-3A60495ACAA7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21" creationId="{4F9C6A82-4D0F-41A7-9F5F-7AA274266FDB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22" creationId="{8363D60A-D0EF-4390-87A7-DE89993C5C01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23" creationId="{128B8CB3-34B7-4BED-8E54-29EAD35DDC1D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24" creationId="{7EAF98A8-9402-4399-8756-D0B0DF267C50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25" creationId="{0A874181-31F6-4A43-BBA6-A97DC4BABE4D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26" creationId="{FCA5B629-8F8C-4A66-8A89-C3CB48FB892A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27" creationId="{EE1C7CEB-FDB7-4ADA-ADFE-CCABA29F3FFC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28" creationId="{DC84BCC2-B2A9-4D3B-9017-FA580E237B60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31" creationId="{8A2AA2A5-1DF6-42FE-9692-3BDD887DE81D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32" creationId="{7FC29912-3C8F-484B-A709-CB48593F4133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33" creationId="{142B0DB7-C21F-4FB6-A9DB-08616D18A2C7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36" creationId="{3475A83D-945E-4862-A9BF-6EEC875454A1}"/>
          </ac:spMkLst>
        </pc:spChg>
        <pc:spChg chg="add mod">
          <ac:chgData name="Tekle Pauzaite" userId="06f7e524-8501-4f81-9b2a-484f6f2c7061" providerId="ADAL" clId="{E54163B5-263A-464A-8812-9DEBC385B07B}" dt="2024-03-27T11:02:04.008" v="4" actId="1076"/>
          <ac:spMkLst>
            <pc:docMk/>
            <pc:sldMk cId="203325691" sldId="256"/>
            <ac:spMk id="37" creationId="{54D16704-FFE1-4159-B83C-D7099E70C0AF}"/>
          </ac:spMkLst>
        </pc:spChg>
        <pc:spChg chg="add mod">
          <ac:chgData name="Tekle Pauzaite" userId="06f7e524-8501-4f81-9b2a-484f6f2c7061" providerId="ADAL" clId="{E54163B5-263A-464A-8812-9DEBC385B07B}" dt="2024-03-27T11:02:04.008" v="4" actId="1076"/>
          <ac:spMkLst>
            <pc:docMk/>
            <pc:sldMk cId="203325691" sldId="256"/>
            <ac:spMk id="38" creationId="{D6D868C4-D089-474D-BF1F-EC431464F935}"/>
          </ac:spMkLst>
        </pc:spChg>
        <pc:spChg chg="add mod">
          <ac:chgData name="Tekle Pauzaite" userId="06f7e524-8501-4f81-9b2a-484f6f2c7061" providerId="ADAL" clId="{E54163B5-263A-464A-8812-9DEBC385B07B}" dt="2024-03-27T11:02:04.008" v="4" actId="1076"/>
          <ac:spMkLst>
            <pc:docMk/>
            <pc:sldMk cId="203325691" sldId="256"/>
            <ac:spMk id="39" creationId="{9BAD2D59-0F71-43E9-8D0C-81650E2A5FA8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42" creationId="{739E655E-026E-4A11-A2F0-455928F1ED4B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43" creationId="{AFD34BEA-65CD-4AD4-AA9B-16EC868375BE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45" creationId="{14D3DC09-97E6-426B-B034-4BFF9BAA0811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46" creationId="{72F7D465-44D5-48E2-AB27-AD3680BC2CF6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47" creationId="{9F1E2FD6-0EFE-46FC-900D-E7CC0C5CAC4A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48" creationId="{B46775DA-7B1D-4ACF-B1A6-C9703AA2BCB6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51" creationId="{4A798A98-F217-4C90-BDFA-3405B7816898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52" creationId="{7F0FB564-9EA5-4A4B-B977-E77D95129981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53" creationId="{C53D99AF-D5A7-4668-A052-930E398A074E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54" creationId="{93F47AC2-ACA2-4616-9AD6-686407393944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55" creationId="{F8AFF98B-413E-4A12-AC4B-1BFCE26533D0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56" creationId="{F0B9C676-CF96-438B-B946-9E28320E49C0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57" creationId="{9DD34190-F1B6-43D9-8A2A-31C9FA2D81AB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58" creationId="{85E4FD59-D3B2-4737-A044-361E962C77C6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59" creationId="{E74FD5B7-0030-40F0-9D32-4358F561BDEC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60" creationId="{752EC273-8C16-46C7-946F-6497A86BE516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61" creationId="{1B32E860-B2BA-440C-ACDD-3BF5AF90EE8B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62" creationId="{4E89AF2B-050E-43DF-8BCC-6EEED5A63CDB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63" creationId="{890FBA3F-5103-41A8-B246-7FBE16C34EA2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64" creationId="{E52E709F-02C6-44FC-B3D8-5DB535233CA9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65" creationId="{0EC4E9E5-CD60-4EB6-B32A-815EC216C2CF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66" creationId="{54F0FAB6-F851-42C5-8CF1-6C1F4925E4CC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67" creationId="{C0046532-D5E9-410B-838B-856965E8F10F}"/>
          </ac:spMkLst>
        </pc:spChg>
        <pc:spChg chg="add mod">
          <ac:chgData name="Tekle Pauzaite" userId="06f7e524-8501-4f81-9b2a-484f6f2c7061" providerId="ADAL" clId="{E54163B5-263A-464A-8812-9DEBC385B07B}" dt="2024-03-27T11:02:04.008" v="4" actId="1076"/>
          <ac:spMkLst>
            <pc:docMk/>
            <pc:sldMk cId="203325691" sldId="256"/>
            <ac:spMk id="70" creationId="{A2D7228F-591B-4455-BEED-F1739DBCE1BB}"/>
          </ac:spMkLst>
        </pc:spChg>
        <pc:spChg chg="add mod">
          <ac:chgData name="Tekle Pauzaite" userId="06f7e524-8501-4f81-9b2a-484f6f2c7061" providerId="ADAL" clId="{E54163B5-263A-464A-8812-9DEBC385B07B}" dt="2024-03-27T11:04:13.662" v="63" actId="208"/>
          <ac:spMkLst>
            <pc:docMk/>
            <pc:sldMk cId="203325691" sldId="256"/>
            <ac:spMk id="75" creationId="{E540BCA3-11F7-4ED6-957A-BB15890BAF38}"/>
          </ac:spMkLst>
        </pc:spChg>
        <pc:spChg chg="add mod">
          <ac:chgData name="Tekle Pauzaite" userId="06f7e524-8501-4f81-9b2a-484f6f2c7061" providerId="ADAL" clId="{E54163B5-263A-464A-8812-9DEBC385B07B}" dt="2024-03-27T11:04:21.486" v="65" actId="14100"/>
          <ac:spMkLst>
            <pc:docMk/>
            <pc:sldMk cId="203325691" sldId="256"/>
            <ac:spMk id="76" creationId="{7987A85D-1847-4A1C-BACC-A42C1C326DCD}"/>
          </ac:spMkLst>
        </pc:spChg>
        <pc:spChg chg="add mod">
          <ac:chgData name="Tekle Pauzaite" userId="06f7e524-8501-4f81-9b2a-484f6f2c7061" providerId="ADAL" clId="{E54163B5-263A-464A-8812-9DEBC385B07B}" dt="2024-03-27T11:04:38.533" v="72" actId="1035"/>
          <ac:spMkLst>
            <pc:docMk/>
            <pc:sldMk cId="203325691" sldId="256"/>
            <ac:spMk id="77" creationId="{36D956B8-858D-4EE7-88C8-DACE26C957E7}"/>
          </ac:spMkLst>
        </pc:spChg>
        <pc:spChg chg="add mod">
          <ac:chgData name="Tekle Pauzaite" userId="06f7e524-8501-4f81-9b2a-484f6f2c7061" providerId="ADAL" clId="{E54163B5-263A-464A-8812-9DEBC385B07B}" dt="2024-03-27T11:04:45.550" v="73" actId="571"/>
          <ac:spMkLst>
            <pc:docMk/>
            <pc:sldMk cId="203325691" sldId="256"/>
            <ac:spMk id="78" creationId="{1F8E30D5-0290-4E57-9C3E-E750E1A14923}"/>
          </ac:spMkLst>
        </pc:spChg>
        <pc:spChg chg="add mod">
          <ac:chgData name="Tekle Pauzaite" userId="06f7e524-8501-4f81-9b2a-484f6f2c7061" providerId="ADAL" clId="{E54163B5-263A-464A-8812-9DEBC385B07B}" dt="2024-03-27T11:05:02.511" v="74" actId="571"/>
          <ac:spMkLst>
            <pc:docMk/>
            <pc:sldMk cId="203325691" sldId="256"/>
            <ac:spMk id="79" creationId="{F9925C89-6632-4F83-BA87-5708BE50C3A1}"/>
          </ac:spMkLst>
        </pc:spChg>
        <pc:spChg chg="add mod">
          <ac:chgData name="Tekle Pauzaite" userId="06f7e524-8501-4f81-9b2a-484f6f2c7061" providerId="ADAL" clId="{E54163B5-263A-464A-8812-9DEBC385B07B}" dt="2024-03-27T11:05:08.246" v="75" actId="571"/>
          <ac:spMkLst>
            <pc:docMk/>
            <pc:sldMk cId="203325691" sldId="256"/>
            <ac:spMk id="80" creationId="{E8CA1C0B-0060-4688-9D0D-440D31A13EEB}"/>
          </ac:spMkLst>
        </pc:spChg>
        <pc:spChg chg="add 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81" creationId="{B1F158D1-78CD-453C-9B0D-DAD768512ADC}"/>
          </ac:spMkLst>
        </pc:spChg>
        <pc:spChg chg="add 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82" creationId="{F47F5797-FB5A-408F-A669-823E35A7B654}"/>
          </ac:spMkLst>
        </pc:spChg>
        <pc:grpChg chg="add del mod">
          <ac:chgData name="Tekle Pauzaite" userId="06f7e524-8501-4f81-9b2a-484f6f2c7061" providerId="ADAL" clId="{E54163B5-263A-464A-8812-9DEBC385B07B}" dt="2024-03-27T11:05:22.536" v="78" actId="165"/>
          <ac:grpSpMkLst>
            <pc:docMk/>
            <pc:sldMk cId="203325691" sldId="256"/>
            <ac:grpSpMk id="40" creationId="{0D418DBE-3078-4A40-853D-14E26130965B}"/>
          </ac:grpSpMkLst>
        </pc:grpChg>
        <pc:picChg chg="add">
          <ac:chgData name="Tekle Pauzaite" userId="06f7e524-8501-4f81-9b2a-484f6f2c7061" providerId="ADAL" clId="{E54163B5-263A-464A-8812-9DEBC385B07B}" dt="2024-03-27T11:01:38.983" v="2"/>
          <ac:picMkLst>
            <pc:docMk/>
            <pc:sldMk cId="203325691" sldId="256"/>
            <ac:picMk id="29" creationId="{DACA3AE1-A681-48F2-A062-5CA73A10FC5F}"/>
          </ac:picMkLst>
        </pc:picChg>
        <pc:picChg chg="add">
          <ac:chgData name="Tekle Pauzaite" userId="06f7e524-8501-4f81-9b2a-484f6f2c7061" providerId="ADAL" clId="{E54163B5-263A-464A-8812-9DEBC385B07B}" dt="2024-03-27T11:01:38.983" v="2"/>
          <ac:picMkLst>
            <pc:docMk/>
            <pc:sldMk cId="203325691" sldId="256"/>
            <ac:picMk id="30" creationId="{9DAFD580-061A-47F2-A319-2907674A4599}"/>
          </ac:picMkLst>
        </pc:picChg>
        <pc:picChg chg="mod topLvl">
          <ac:chgData name="Tekle Pauzaite" userId="06f7e524-8501-4f81-9b2a-484f6f2c7061" providerId="ADAL" clId="{E54163B5-263A-464A-8812-9DEBC385B07B}" dt="2024-03-27T11:05:22.536" v="78" actId="165"/>
          <ac:picMkLst>
            <pc:docMk/>
            <pc:sldMk cId="203325691" sldId="256"/>
            <ac:picMk id="41" creationId="{8DA3138D-8327-44E8-8C82-E954FF63936D}"/>
          </ac:picMkLst>
        </pc:picChg>
        <pc:picChg chg="mod topLvl">
          <ac:chgData name="Tekle Pauzaite" userId="06f7e524-8501-4f81-9b2a-484f6f2c7061" providerId="ADAL" clId="{E54163B5-263A-464A-8812-9DEBC385B07B}" dt="2024-03-27T11:05:22.536" v="78" actId="165"/>
          <ac:picMkLst>
            <pc:docMk/>
            <pc:sldMk cId="203325691" sldId="256"/>
            <ac:picMk id="44" creationId="{29921129-A367-41D7-B58F-AB24A1689A34}"/>
          </ac:picMkLst>
        </pc:picChg>
        <pc:picChg chg="add mod modCrop">
          <ac:chgData name="Tekle Pauzaite" userId="06f7e524-8501-4f81-9b2a-484f6f2c7061" providerId="ADAL" clId="{E54163B5-263A-464A-8812-9DEBC385B07B}" dt="2024-03-27T11:02:42.462" v="19" actId="1076"/>
          <ac:picMkLst>
            <pc:docMk/>
            <pc:sldMk cId="203325691" sldId="256"/>
            <ac:picMk id="71" creationId="{B2DE2E4B-C9C7-4674-ACC2-8FF8ACB1B045}"/>
          </ac:picMkLst>
        </pc:picChg>
        <pc:picChg chg="add mod modCrop">
          <ac:chgData name="Tekle Pauzaite" userId="06f7e524-8501-4f81-9b2a-484f6f2c7061" providerId="ADAL" clId="{E54163B5-263A-464A-8812-9DEBC385B07B}" dt="2024-03-27T11:03:01.070" v="30" actId="1076"/>
          <ac:picMkLst>
            <pc:docMk/>
            <pc:sldMk cId="203325691" sldId="256"/>
            <ac:picMk id="72" creationId="{867C5C5E-7C13-45D5-83A7-5946D12F2294}"/>
          </ac:picMkLst>
        </pc:picChg>
        <pc:picChg chg="add mod ord modCrop">
          <ac:chgData name="Tekle Pauzaite" userId="06f7e524-8501-4f81-9b2a-484f6f2c7061" providerId="ADAL" clId="{E54163B5-263A-464A-8812-9DEBC385B07B}" dt="2024-03-27T11:05:26.002" v="79" actId="167"/>
          <ac:picMkLst>
            <pc:docMk/>
            <pc:sldMk cId="203325691" sldId="256"/>
            <ac:picMk id="73" creationId="{FE579EC1-5328-4759-A5AD-5CB70D7D96D9}"/>
          </ac:picMkLst>
        </pc:picChg>
        <pc:picChg chg="add mod ord modCrop">
          <ac:chgData name="Tekle Pauzaite" userId="06f7e524-8501-4f81-9b2a-484f6f2c7061" providerId="ADAL" clId="{E54163B5-263A-464A-8812-9DEBC385B07B}" dt="2024-03-27T11:05:27.834" v="80" actId="167"/>
          <ac:picMkLst>
            <pc:docMk/>
            <pc:sldMk cId="203325691" sldId="256"/>
            <ac:picMk id="74" creationId="{180FAA85-93ED-4D0F-97CD-7592201399ED}"/>
          </ac:picMkLst>
        </pc:picChg>
        <pc:cxnChg chg="add">
          <ac:chgData name="Tekle Pauzaite" userId="06f7e524-8501-4f81-9b2a-484f6f2c7061" providerId="ADAL" clId="{E54163B5-263A-464A-8812-9DEBC385B07B}" dt="2024-03-27T11:01:38.983" v="2"/>
          <ac:cxnSpMkLst>
            <pc:docMk/>
            <pc:sldMk cId="203325691" sldId="256"/>
            <ac:cxnSpMk id="10" creationId="{5DC27655-A531-4142-890C-2A36FD0B68CB}"/>
          </ac:cxnSpMkLst>
        </pc:cxnChg>
        <pc:cxnChg chg="add">
          <ac:chgData name="Tekle Pauzaite" userId="06f7e524-8501-4f81-9b2a-484f6f2c7061" providerId="ADAL" clId="{E54163B5-263A-464A-8812-9DEBC385B07B}" dt="2024-03-27T11:01:38.983" v="2"/>
          <ac:cxnSpMkLst>
            <pc:docMk/>
            <pc:sldMk cId="203325691" sldId="256"/>
            <ac:cxnSpMk id="12" creationId="{0083257C-F190-4F45-A397-9D7689222743}"/>
          </ac:cxnSpMkLst>
        </pc:cxnChg>
        <pc:cxnChg chg="add">
          <ac:chgData name="Tekle Pauzaite" userId="06f7e524-8501-4f81-9b2a-484f6f2c7061" providerId="ADAL" clId="{E54163B5-263A-464A-8812-9DEBC385B07B}" dt="2024-03-27T11:01:38.983" v="2"/>
          <ac:cxnSpMkLst>
            <pc:docMk/>
            <pc:sldMk cId="203325691" sldId="256"/>
            <ac:cxnSpMk id="34" creationId="{D06B2955-3E19-4F75-8CE9-9B6DCDE535C3}"/>
          </ac:cxnSpMkLst>
        </pc:cxnChg>
        <pc:cxnChg chg="add">
          <ac:chgData name="Tekle Pauzaite" userId="06f7e524-8501-4f81-9b2a-484f6f2c7061" providerId="ADAL" clId="{E54163B5-263A-464A-8812-9DEBC385B07B}" dt="2024-03-27T11:01:38.983" v="2"/>
          <ac:cxnSpMkLst>
            <pc:docMk/>
            <pc:sldMk cId="203325691" sldId="256"/>
            <ac:cxnSpMk id="35" creationId="{8E3B2768-441B-46F3-BB08-F193BBFD46CE}"/>
          </ac:cxnSpMkLst>
        </pc:cxnChg>
        <pc:cxnChg chg="mod topLvl">
          <ac:chgData name="Tekle Pauzaite" userId="06f7e524-8501-4f81-9b2a-484f6f2c7061" providerId="ADAL" clId="{E54163B5-263A-464A-8812-9DEBC385B07B}" dt="2024-03-27T11:05:22.536" v="78" actId="165"/>
          <ac:cxnSpMkLst>
            <pc:docMk/>
            <pc:sldMk cId="203325691" sldId="256"/>
            <ac:cxnSpMk id="49" creationId="{0052B02D-79EA-4D96-A0AB-2A278D38204A}"/>
          </ac:cxnSpMkLst>
        </pc:cxnChg>
        <pc:cxnChg chg="mod topLvl">
          <ac:chgData name="Tekle Pauzaite" userId="06f7e524-8501-4f81-9b2a-484f6f2c7061" providerId="ADAL" clId="{E54163B5-263A-464A-8812-9DEBC385B07B}" dt="2024-03-27T11:05:22.536" v="78" actId="165"/>
          <ac:cxnSpMkLst>
            <pc:docMk/>
            <pc:sldMk cId="203325691" sldId="256"/>
            <ac:cxnSpMk id="50" creationId="{A464202C-2E9C-46F2-BEDB-2EE5948521A1}"/>
          </ac:cxnSpMkLst>
        </pc:cxnChg>
        <pc:cxnChg chg="mod topLvl">
          <ac:chgData name="Tekle Pauzaite" userId="06f7e524-8501-4f81-9b2a-484f6f2c7061" providerId="ADAL" clId="{E54163B5-263A-464A-8812-9DEBC385B07B}" dt="2024-03-27T11:05:22.536" v="78" actId="165"/>
          <ac:cxnSpMkLst>
            <pc:docMk/>
            <pc:sldMk cId="203325691" sldId="256"/>
            <ac:cxnSpMk id="68" creationId="{3DEE365E-EEA5-4B54-9CD4-C5C07D18599F}"/>
          </ac:cxnSpMkLst>
        </pc:cxnChg>
        <pc:cxnChg chg="mod topLvl">
          <ac:chgData name="Tekle Pauzaite" userId="06f7e524-8501-4f81-9b2a-484f6f2c7061" providerId="ADAL" clId="{E54163B5-263A-464A-8812-9DEBC385B07B}" dt="2024-03-27T11:05:22.536" v="78" actId="165"/>
          <ac:cxnSpMkLst>
            <pc:docMk/>
            <pc:sldMk cId="203325691" sldId="256"/>
            <ac:cxnSpMk id="69" creationId="{E633AAE6-2937-4F1B-A607-2DE6BE831F1A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569ECB-FF48-40B4-85D4-A32A0A65CBE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FF4D729-8BE7-435C-B2D5-8EC4D01BA0F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E43479-77C8-4CDE-A297-3C14C3696F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004EE-3987-426A-9850-C4A8FD39DB25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C2AFDA-43A8-443C-8586-52F87FD9A6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4A17D1-0ADB-47E9-A365-AC74CE6507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D4EF2-AA88-476B-8BAD-F1D3DBFB9C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23863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10ED5D-B389-490C-9865-42F0788468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7CB5594-ADE1-4D01-898A-E13129599C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125BA5-1362-4192-9508-D09B326CBC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004EE-3987-426A-9850-C4A8FD39DB25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EF317F-5016-47FD-B85D-E774EE5600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431298-4B3D-4780-9077-38FB74905B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D4EF2-AA88-476B-8BAD-F1D3DBFB9C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38882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BFF4554-82CE-4A40-B86D-71DE2F4E008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1ABF518-6F8D-4897-982C-9E08EA914DD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B444DF-ECDD-42B4-9B6D-9F85346418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004EE-3987-426A-9850-C4A8FD39DB25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E2B872-7E6B-4B65-8BE6-40CD2C9CB7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6B3B14-7199-4AE8-967E-A5BF820F4F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D4EF2-AA88-476B-8BAD-F1D3DBFB9C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92249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3011EE-34C5-41AA-9582-8E81374851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5AB248-297D-4EED-8286-68E654E370F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E18561-4090-44FE-9564-F232A1A56B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004EE-3987-426A-9850-C4A8FD39DB25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D49382-553A-45A9-9ABF-9DE451F511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7C369D-CA2D-42CC-9F7A-786482B943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D4EF2-AA88-476B-8BAD-F1D3DBFB9C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66505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98688C-A853-47AD-B538-85F831B5C1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7D2358A-0896-4CC8-99E7-9528D826C6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0F35D3-E6C0-4DF2-A18D-FE76602DB7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004EE-3987-426A-9850-C4A8FD39DB25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92443D-85A3-4B87-9A5A-DA0E37E65C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9E4180-DBD0-42E1-A2FE-9E25AB87F5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D4EF2-AA88-476B-8BAD-F1D3DBFB9C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25698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87B36B-C82D-43AD-9FFB-88193F488F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409756-4FE8-483E-8263-A9A89DD99BE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C70EEDE-2B1E-4D29-8359-C3F83188AF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02F9865-379C-410A-AD29-786887E452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004EE-3987-426A-9850-C4A8FD39DB25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702AF41-7C53-4655-81AD-1AACBDC71D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AA3027C-E6BF-417D-BB84-0F52DB36E1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D4EF2-AA88-476B-8BAD-F1D3DBFB9C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8938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5EF039-CF9E-49A7-B1BB-CA796F853A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C10078-DFDF-498B-AACD-5386F07E10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A4E74C7-2EDF-463B-9B6D-549B558D18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DD91C2A-C53F-47E6-BEC5-B7C38A885CD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B3BFBB9-756D-4394-9AB3-0E5D1D1A32D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0A1FB05-AC3E-4AE9-AF0A-A2C29AD821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004EE-3987-426A-9850-C4A8FD39DB25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C7CF016-1273-47E9-9319-343B0A607E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D264A28-ADCA-441F-B984-7141C5CE71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D4EF2-AA88-476B-8BAD-F1D3DBFB9C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47595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4CE218-9B63-4305-AC66-DEE4F6D7FD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0F37E9B-6729-4356-ADFA-D023958A25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004EE-3987-426A-9850-C4A8FD39DB25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F33D06E-3858-4BCE-90A2-40F418BF57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13E3791-38B1-47A7-98A8-A42E28F6AE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D4EF2-AA88-476B-8BAD-F1D3DBFB9C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11964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D833867-2585-4F6B-B1DD-1F69FA245C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004EE-3987-426A-9850-C4A8FD39DB25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05B5ED9-B716-4F6F-A470-7E58EE9C12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7892CAD-ABE0-4140-A1D5-A2EC94B4ED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D4EF2-AA88-476B-8BAD-F1D3DBFB9C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57015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8C1346-82C4-4556-B75C-042793DFFB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6C272B9-55A7-4FBD-8332-3DF41D72277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BAB5C1D-B75B-4572-A889-CCF1D3479A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C50D73-C227-4619-A302-5582DD6A71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004EE-3987-426A-9850-C4A8FD39DB25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D900CCA-A26F-4AA3-BE89-1E81D00279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399F2DD-6DA6-443D-9045-75A577DF0A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D4EF2-AA88-476B-8BAD-F1D3DBFB9C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85627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0A5E32-B45A-4C12-A4B0-582B336BD5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366521A-C5F6-4BEF-8706-640A9AE4566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35C34EC-8703-485C-A02B-87941C2D72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D3BF7C-FDB4-4692-9C51-DCBD2E26E1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004EE-3987-426A-9850-C4A8FD39DB25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EB98AC9-787D-4869-B21C-5FBC3E8674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1132886-D15A-475D-B335-064F783CE1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D4EF2-AA88-476B-8BAD-F1D3DBFB9C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14728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7D1940E-B9FB-46A3-B2E3-6C0FF94319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01D88E-300E-4DD4-8740-3B93870E70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5ADA9E-89B4-4D49-9DEC-249A9D9EF68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6004EE-3987-426A-9850-C4A8FD39DB25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41B774-D54F-405F-99EA-6A7ADB69698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270236-09FA-48A7-A25D-AD8571560F7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AD4EF2-AA88-476B-8BAD-F1D3DBFB9C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01990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4" name="Picture 73">
            <a:extLst>
              <a:ext uri="{FF2B5EF4-FFF2-40B4-BE49-F238E27FC236}">
                <a16:creationId xmlns:a16="http://schemas.microsoft.com/office/drawing/2014/main" id="{180FAA85-93ED-4D0F-97CD-7592201399ED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32" t="-24" r="-818" b="-847"/>
          <a:stretch/>
        </p:blipFill>
        <p:spPr>
          <a:xfrm rot="5400000">
            <a:off x="6393099" y="2223908"/>
            <a:ext cx="2320610" cy="285044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3" name="Picture 72">
            <a:extLst>
              <a:ext uri="{FF2B5EF4-FFF2-40B4-BE49-F238E27FC236}">
                <a16:creationId xmlns:a16="http://schemas.microsoft.com/office/drawing/2014/main" id="{FE579EC1-5328-4759-A5AD-5CB70D7D96D9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44" t="172" r="604" b="-40"/>
          <a:stretch/>
        </p:blipFill>
        <p:spPr>
          <a:xfrm rot="5400000">
            <a:off x="3385407" y="2271591"/>
            <a:ext cx="2304316" cy="273878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CF0EF0D-E25D-4487-8800-374F393F33C1}"/>
              </a:ext>
            </a:extLst>
          </p:cNvPr>
          <p:cNvSpPr txBox="1"/>
          <p:nvPr/>
        </p:nvSpPr>
        <p:spPr>
          <a:xfrm>
            <a:off x="69022" y="44622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101D58E-CCBB-48DC-A636-7F424B63A38B}"/>
              </a:ext>
            </a:extLst>
          </p:cNvPr>
          <p:cNvSpPr txBox="1"/>
          <p:nvPr/>
        </p:nvSpPr>
        <p:spPr>
          <a:xfrm>
            <a:off x="2026048" y="716802"/>
            <a:ext cx="7409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6 h 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490C55C-481F-4348-9403-EF1E7C0A342E}"/>
              </a:ext>
            </a:extLst>
          </p:cNvPr>
          <p:cNvSpPr txBox="1"/>
          <p:nvPr/>
        </p:nvSpPr>
        <p:spPr>
          <a:xfrm>
            <a:off x="666755" y="685052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EDED5FA-3F8E-45EC-A470-F020DA8E223B}"/>
              </a:ext>
            </a:extLst>
          </p:cNvPr>
          <p:cNvSpPr txBox="1"/>
          <p:nvPr/>
        </p:nvSpPr>
        <p:spPr>
          <a:xfrm>
            <a:off x="818489" y="685052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058E431-945F-4905-A8A2-7DDABE241F4C}"/>
              </a:ext>
            </a:extLst>
          </p:cNvPr>
          <p:cNvSpPr txBox="1"/>
          <p:nvPr/>
        </p:nvSpPr>
        <p:spPr>
          <a:xfrm>
            <a:off x="987353" y="685052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CF5EA6D-711E-469B-AB79-9102F31E32FE}"/>
              </a:ext>
            </a:extLst>
          </p:cNvPr>
          <p:cNvSpPr txBox="1"/>
          <p:nvPr/>
        </p:nvSpPr>
        <p:spPr>
          <a:xfrm>
            <a:off x="759937" y="524284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5DC27655-A531-4142-890C-2A36FD0B68CB}"/>
              </a:ext>
            </a:extLst>
          </p:cNvPr>
          <p:cNvCxnSpPr>
            <a:cxnSpLocks/>
          </p:cNvCxnSpPr>
          <p:nvPr/>
        </p:nvCxnSpPr>
        <p:spPr>
          <a:xfrm>
            <a:off x="751326" y="742093"/>
            <a:ext cx="535447" cy="17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97C678FE-5424-4E4E-8689-2AF6DF4CDF58}"/>
              </a:ext>
            </a:extLst>
          </p:cNvPr>
          <p:cNvSpPr txBox="1"/>
          <p:nvPr/>
        </p:nvSpPr>
        <p:spPr>
          <a:xfrm>
            <a:off x="1345984" y="528341"/>
            <a:ext cx="6912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 IP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0083257C-F190-4F45-A397-9D7689222743}"/>
              </a:ext>
            </a:extLst>
          </p:cNvPr>
          <p:cNvCxnSpPr>
            <a:cxnSpLocks/>
          </p:cNvCxnSpPr>
          <p:nvPr/>
        </p:nvCxnSpPr>
        <p:spPr>
          <a:xfrm>
            <a:off x="1412492" y="742093"/>
            <a:ext cx="535447" cy="17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93A81E34-BBC7-4428-8BAA-08294754CAAD}"/>
              </a:ext>
            </a:extLst>
          </p:cNvPr>
          <p:cNvSpPr txBox="1"/>
          <p:nvPr/>
        </p:nvSpPr>
        <p:spPr>
          <a:xfrm>
            <a:off x="1139087" y="685052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4C33F19-1077-4DF4-87FA-BB1BC398C29D}"/>
              </a:ext>
            </a:extLst>
          </p:cNvPr>
          <p:cNvSpPr txBox="1"/>
          <p:nvPr/>
        </p:nvSpPr>
        <p:spPr>
          <a:xfrm>
            <a:off x="1324176" y="685052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FD3B7D5-C3F9-46AF-BBCB-E85CF5CA2B94}"/>
              </a:ext>
            </a:extLst>
          </p:cNvPr>
          <p:cNvSpPr txBox="1"/>
          <p:nvPr/>
        </p:nvSpPr>
        <p:spPr>
          <a:xfrm>
            <a:off x="1475910" y="685052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D476953-3325-4C31-BA97-6CB78A54874A}"/>
              </a:ext>
            </a:extLst>
          </p:cNvPr>
          <p:cNvSpPr txBox="1"/>
          <p:nvPr/>
        </p:nvSpPr>
        <p:spPr>
          <a:xfrm>
            <a:off x="1644775" y="685052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3DB05F2-B61F-4599-A112-D5F6CD791DC3}"/>
              </a:ext>
            </a:extLst>
          </p:cNvPr>
          <p:cNvSpPr txBox="1"/>
          <p:nvPr/>
        </p:nvSpPr>
        <p:spPr>
          <a:xfrm>
            <a:off x="1796508" y="685052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C67FE52-BD2D-49A9-9A6B-E82774EC008A}"/>
              </a:ext>
            </a:extLst>
          </p:cNvPr>
          <p:cNvSpPr txBox="1"/>
          <p:nvPr/>
        </p:nvSpPr>
        <p:spPr>
          <a:xfrm>
            <a:off x="2036996" y="1349073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DE82CF0-7027-491F-B297-C5AA1390ECAC}"/>
              </a:ext>
            </a:extLst>
          </p:cNvPr>
          <p:cNvSpPr txBox="1"/>
          <p:nvPr/>
        </p:nvSpPr>
        <p:spPr>
          <a:xfrm>
            <a:off x="2026048" y="967929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33B0EC6-2476-43FF-829E-3A60495ACAA7}"/>
              </a:ext>
            </a:extLst>
          </p:cNvPr>
          <p:cNvSpPr txBox="1"/>
          <p:nvPr/>
        </p:nvSpPr>
        <p:spPr>
          <a:xfrm>
            <a:off x="2008095" y="1562598"/>
            <a:ext cx="7489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gG control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F9C6A82-4D0F-41A7-9F5F-7AA274266FDB}"/>
              </a:ext>
            </a:extLst>
          </p:cNvPr>
          <p:cNvSpPr txBox="1"/>
          <p:nvPr/>
        </p:nvSpPr>
        <p:spPr>
          <a:xfrm>
            <a:off x="801003" y="1579617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363D60A-D0EF-4390-87A7-DE89993C5C01}"/>
              </a:ext>
            </a:extLst>
          </p:cNvPr>
          <p:cNvSpPr txBox="1"/>
          <p:nvPr/>
        </p:nvSpPr>
        <p:spPr>
          <a:xfrm>
            <a:off x="635121" y="1574869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28B8CB3-34B7-4BED-8E54-29EAD35DDC1D}"/>
              </a:ext>
            </a:extLst>
          </p:cNvPr>
          <p:cNvSpPr txBox="1"/>
          <p:nvPr/>
        </p:nvSpPr>
        <p:spPr>
          <a:xfrm>
            <a:off x="1116576" y="1576504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EAF98A8-9402-4399-8756-D0B0DF267C50}"/>
              </a:ext>
            </a:extLst>
          </p:cNvPr>
          <p:cNvSpPr txBox="1"/>
          <p:nvPr/>
        </p:nvSpPr>
        <p:spPr>
          <a:xfrm>
            <a:off x="950694" y="1571756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A874181-31F6-4A43-BBA6-A97DC4BABE4D}"/>
              </a:ext>
            </a:extLst>
          </p:cNvPr>
          <p:cNvSpPr txBox="1"/>
          <p:nvPr/>
        </p:nvSpPr>
        <p:spPr>
          <a:xfrm>
            <a:off x="1472621" y="1571756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CA5B629-8F8C-4A66-8A89-C3CB48FB892A}"/>
              </a:ext>
            </a:extLst>
          </p:cNvPr>
          <p:cNvSpPr txBox="1"/>
          <p:nvPr/>
        </p:nvSpPr>
        <p:spPr>
          <a:xfrm>
            <a:off x="1306740" y="1567009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E1C7CEB-FDB7-4ADA-ADFE-CCABA29F3FFC}"/>
              </a:ext>
            </a:extLst>
          </p:cNvPr>
          <p:cNvSpPr txBox="1"/>
          <p:nvPr/>
        </p:nvSpPr>
        <p:spPr>
          <a:xfrm>
            <a:off x="1828668" y="1575223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C84BCC2-B2A9-4D3B-9017-FA580E237B60}"/>
              </a:ext>
            </a:extLst>
          </p:cNvPr>
          <p:cNvSpPr txBox="1"/>
          <p:nvPr/>
        </p:nvSpPr>
        <p:spPr>
          <a:xfrm>
            <a:off x="1662786" y="1570476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DACA3AE1-A681-48F2-A062-5CA73A10FC5F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893" t="57231" r="72200" b="16522"/>
          <a:stretch/>
        </p:blipFill>
        <p:spPr>
          <a:xfrm rot="5400000">
            <a:off x="1173226" y="381238"/>
            <a:ext cx="354097" cy="135154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9DAFD580-061A-47F2-A319-2907674A4599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868" t="30846" r="65102" b="13639"/>
          <a:stretch/>
        </p:blipFill>
        <p:spPr>
          <a:xfrm rot="5400000">
            <a:off x="1175147" y="768172"/>
            <a:ext cx="350251" cy="135154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8A2AA2A5-1DF6-42FE-9692-3BDD887DE81D}"/>
              </a:ext>
            </a:extLst>
          </p:cNvPr>
          <p:cNvSpPr txBox="1"/>
          <p:nvPr/>
        </p:nvSpPr>
        <p:spPr>
          <a:xfrm>
            <a:off x="265619" y="674957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FC29912-3C8F-484B-A709-CB48593F4133}"/>
              </a:ext>
            </a:extLst>
          </p:cNvPr>
          <p:cNvSpPr txBox="1"/>
          <p:nvPr/>
        </p:nvSpPr>
        <p:spPr>
          <a:xfrm>
            <a:off x="282992" y="1238610"/>
            <a:ext cx="283265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142B0DB7-C21F-4FB6-A9DB-08616D18A2C7}"/>
              </a:ext>
            </a:extLst>
          </p:cNvPr>
          <p:cNvSpPr txBox="1"/>
          <p:nvPr/>
        </p:nvSpPr>
        <p:spPr>
          <a:xfrm>
            <a:off x="331167" y="905570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D06B2955-3E19-4F75-8CE9-9B6DCDE535C3}"/>
              </a:ext>
            </a:extLst>
          </p:cNvPr>
          <p:cNvCxnSpPr/>
          <p:nvPr/>
        </p:nvCxnSpPr>
        <p:spPr>
          <a:xfrm>
            <a:off x="584447" y="1356238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8E3B2768-441B-46F3-BB08-F193BBFD46CE}"/>
              </a:ext>
            </a:extLst>
          </p:cNvPr>
          <p:cNvCxnSpPr/>
          <p:nvPr/>
        </p:nvCxnSpPr>
        <p:spPr>
          <a:xfrm>
            <a:off x="584447" y="1015892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3475A83D-945E-4862-A9BF-6EEC875454A1}"/>
              </a:ext>
            </a:extLst>
          </p:cNvPr>
          <p:cNvSpPr txBox="1"/>
          <p:nvPr/>
        </p:nvSpPr>
        <p:spPr>
          <a:xfrm>
            <a:off x="617047" y="1752248"/>
            <a:ext cx="7232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 cells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54D16704-FFE1-4159-B83C-D7099E70C0AF}"/>
              </a:ext>
            </a:extLst>
          </p:cNvPr>
          <p:cNvSpPr txBox="1"/>
          <p:nvPr/>
        </p:nvSpPr>
        <p:spPr>
          <a:xfrm>
            <a:off x="579118" y="2278057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D6D868C4-D089-474D-BF1F-EC431464F935}"/>
              </a:ext>
            </a:extLst>
          </p:cNvPr>
          <p:cNvSpPr txBox="1"/>
          <p:nvPr/>
        </p:nvSpPr>
        <p:spPr>
          <a:xfrm>
            <a:off x="1152465" y="2282114"/>
            <a:ext cx="68159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9BAD2D59-0F71-43E9-8D0C-81650E2A5FA8}"/>
              </a:ext>
            </a:extLst>
          </p:cNvPr>
          <p:cNvSpPr txBox="1"/>
          <p:nvPr/>
        </p:nvSpPr>
        <p:spPr>
          <a:xfrm>
            <a:off x="69022" y="218588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41" name="Picture 40">
            <a:extLst>
              <a:ext uri="{FF2B5EF4-FFF2-40B4-BE49-F238E27FC236}">
                <a16:creationId xmlns:a16="http://schemas.microsoft.com/office/drawing/2014/main" id="{8DA3138D-8327-44E8-8C82-E954FF63936D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765" t="18058" r="39669" b="53859"/>
          <a:stretch/>
        </p:blipFill>
        <p:spPr>
          <a:xfrm rot="5400000">
            <a:off x="992999" y="2131430"/>
            <a:ext cx="350248" cy="136437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739E655E-026E-4A11-A2F0-455928F1ED4B}"/>
              </a:ext>
            </a:extLst>
          </p:cNvPr>
          <p:cNvSpPr txBox="1"/>
          <p:nvPr/>
        </p:nvSpPr>
        <p:spPr>
          <a:xfrm>
            <a:off x="1850309" y="2726216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AFD34BEA-65CD-4AD4-AA9B-16EC868375BE}"/>
              </a:ext>
            </a:extLst>
          </p:cNvPr>
          <p:cNvSpPr txBox="1"/>
          <p:nvPr/>
        </p:nvSpPr>
        <p:spPr>
          <a:xfrm>
            <a:off x="1850307" y="3092072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4" name="Picture 43">
            <a:extLst>
              <a:ext uri="{FF2B5EF4-FFF2-40B4-BE49-F238E27FC236}">
                <a16:creationId xmlns:a16="http://schemas.microsoft.com/office/drawing/2014/main" id="{29921129-A367-41D7-B58F-AB24A1689A3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524" t="16783" r="62006" b="53237"/>
          <a:stretch/>
        </p:blipFill>
        <p:spPr>
          <a:xfrm rot="5400000">
            <a:off x="993445" y="2518928"/>
            <a:ext cx="350249" cy="136437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5" name="TextBox 44">
            <a:extLst>
              <a:ext uri="{FF2B5EF4-FFF2-40B4-BE49-F238E27FC236}">
                <a16:creationId xmlns:a16="http://schemas.microsoft.com/office/drawing/2014/main" id="{14D3DC09-97E6-426B-B034-4BFF9BAA0811}"/>
              </a:ext>
            </a:extLst>
          </p:cNvPr>
          <p:cNvSpPr txBox="1"/>
          <p:nvPr/>
        </p:nvSpPr>
        <p:spPr>
          <a:xfrm>
            <a:off x="1845229" y="2470575"/>
            <a:ext cx="7409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6 h 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72F7D465-44D5-48E2-AB27-AD3680BC2CF6}"/>
              </a:ext>
            </a:extLst>
          </p:cNvPr>
          <p:cNvSpPr txBox="1"/>
          <p:nvPr/>
        </p:nvSpPr>
        <p:spPr>
          <a:xfrm>
            <a:off x="485936" y="2438825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9F1E2FD6-0EFE-46FC-900D-E7CC0C5CAC4A}"/>
              </a:ext>
            </a:extLst>
          </p:cNvPr>
          <p:cNvSpPr txBox="1"/>
          <p:nvPr/>
        </p:nvSpPr>
        <p:spPr>
          <a:xfrm>
            <a:off x="637670" y="2438825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46775DA-7B1D-4ACF-B1A6-C9703AA2BCB6}"/>
              </a:ext>
            </a:extLst>
          </p:cNvPr>
          <p:cNvSpPr txBox="1"/>
          <p:nvPr/>
        </p:nvSpPr>
        <p:spPr>
          <a:xfrm>
            <a:off x="806534" y="2438825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0052B02D-79EA-4D96-A0AB-2A278D38204A}"/>
              </a:ext>
            </a:extLst>
          </p:cNvPr>
          <p:cNvCxnSpPr>
            <a:cxnSpLocks/>
          </p:cNvCxnSpPr>
          <p:nvPr/>
        </p:nvCxnSpPr>
        <p:spPr>
          <a:xfrm>
            <a:off x="570507" y="2474722"/>
            <a:ext cx="535447" cy="17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A464202C-2E9C-46F2-BEDB-2EE5948521A1}"/>
              </a:ext>
            </a:extLst>
          </p:cNvPr>
          <p:cNvCxnSpPr>
            <a:cxnSpLocks/>
          </p:cNvCxnSpPr>
          <p:nvPr/>
        </p:nvCxnSpPr>
        <p:spPr>
          <a:xfrm>
            <a:off x="1231673" y="2474722"/>
            <a:ext cx="535447" cy="17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4A798A98-F217-4C90-BDFA-3405B7816898}"/>
              </a:ext>
            </a:extLst>
          </p:cNvPr>
          <p:cNvSpPr txBox="1"/>
          <p:nvPr/>
        </p:nvSpPr>
        <p:spPr>
          <a:xfrm>
            <a:off x="958268" y="2438825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7F0FB564-9EA5-4A4B-B977-E77D95129981}"/>
              </a:ext>
            </a:extLst>
          </p:cNvPr>
          <p:cNvSpPr txBox="1"/>
          <p:nvPr/>
        </p:nvSpPr>
        <p:spPr>
          <a:xfrm>
            <a:off x="1143357" y="2438825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C53D99AF-D5A7-4668-A052-930E398A074E}"/>
              </a:ext>
            </a:extLst>
          </p:cNvPr>
          <p:cNvSpPr txBox="1"/>
          <p:nvPr/>
        </p:nvSpPr>
        <p:spPr>
          <a:xfrm>
            <a:off x="1295091" y="2438825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93F47AC2-ACA2-4616-9AD6-686407393944}"/>
              </a:ext>
            </a:extLst>
          </p:cNvPr>
          <p:cNvSpPr txBox="1"/>
          <p:nvPr/>
        </p:nvSpPr>
        <p:spPr>
          <a:xfrm>
            <a:off x="1463956" y="2438825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F8AFF98B-413E-4A12-AC4B-1BFCE26533D0}"/>
              </a:ext>
            </a:extLst>
          </p:cNvPr>
          <p:cNvSpPr txBox="1"/>
          <p:nvPr/>
        </p:nvSpPr>
        <p:spPr>
          <a:xfrm>
            <a:off x="1615689" y="2438825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F0B9C676-CF96-438B-B946-9E28320E49C0}"/>
              </a:ext>
            </a:extLst>
          </p:cNvPr>
          <p:cNvSpPr txBox="1"/>
          <p:nvPr/>
        </p:nvSpPr>
        <p:spPr>
          <a:xfrm>
            <a:off x="1834062" y="3331721"/>
            <a:ext cx="7489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gG control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9DD34190-F1B6-43D9-8A2A-31C9FA2D81AB}"/>
              </a:ext>
            </a:extLst>
          </p:cNvPr>
          <p:cNvSpPr txBox="1"/>
          <p:nvPr/>
        </p:nvSpPr>
        <p:spPr>
          <a:xfrm>
            <a:off x="626970" y="3348740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85E4FD59-D3B2-4737-A044-361E962C77C6}"/>
              </a:ext>
            </a:extLst>
          </p:cNvPr>
          <p:cNvSpPr txBox="1"/>
          <p:nvPr/>
        </p:nvSpPr>
        <p:spPr>
          <a:xfrm>
            <a:off x="461088" y="3343992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E74FD5B7-0030-40F0-9D32-4358F561BDEC}"/>
              </a:ext>
            </a:extLst>
          </p:cNvPr>
          <p:cNvSpPr txBox="1"/>
          <p:nvPr/>
        </p:nvSpPr>
        <p:spPr>
          <a:xfrm>
            <a:off x="942543" y="3345627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752EC273-8C16-46C7-946F-6497A86BE516}"/>
              </a:ext>
            </a:extLst>
          </p:cNvPr>
          <p:cNvSpPr txBox="1"/>
          <p:nvPr/>
        </p:nvSpPr>
        <p:spPr>
          <a:xfrm>
            <a:off x="776661" y="3340879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1B32E860-B2BA-440C-ACDD-3BF5AF90EE8B}"/>
              </a:ext>
            </a:extLst>
          </p:cNvPr>
          <p:cNvSpPr txBox="1"/>
          <p:nvPr/>
        </p:nvSpPr>
        <p:spPr>
          <a:xfrm>
            <a:off x="1298588" y="3340879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4E89AF2B-050E-43DF-8BCC-6EEED5A63CDB}"/>
              </a:ext>
            </a:extLst>
          </p:cNvPr>
          <p:cNvSpPr txBox="1"/>
          <p:nvPr/>
        </p:nvSpPr>
        <p:spPr>
          <a:xfrm>
            <a:off x="1132707" y="3336132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890FBA3F-5103-41A8-B246-7FBE16C34EA2}"/>
              </a:ext>
            </a:extLst>
          </p:cNvPr>
          <p:cNvSpPr txBox="1"/>
          <p:nvPr/>
        </p:nvSpPr>
        <p:spPr>
          <a:xfrm>
            <a:off x="1654635" y="3344346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E52E709F-02C6-44FC-B3D8-5DB535233CA9}"/>
              </a:ext>
            </a:extLst>
          </p:cNvPr>
          <p:cNvSpPr txBox="1"/>
          <p:nvPr/>
        </p:nvSpPr>
        <p:spPr>
          <a:xfrm>
            <a:off x="1488753" y="3339599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0EC4E9E5-CD60-4EB6-B32A-815EC216C2CF}"/>
              </a:ext>
            </a:extLst>
          </p:cNvPr>
          <p:cNvSpPr txBox="1"/>
          <p:nvPr/>
        </p:nvSpPr>
        <p:spPr>
          <a:xfrm>
            <a:off x="94183" y="2416193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54F0FAB6-F851-42C5-8CF1-6C1F4925E4CC}"/>
              </a:ext>
            </a:extLst>
          </p:cNvPr>
          <p:cNvSpPr txBox="1"/>
          <p:nvPr/>
        </p:nvSpPr>
        <p:spPr>
          <a:xfrm>
            <a:off x="92672" y="2606959"/>
            <a:ext cx="283265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C0046532-D5E9-410B-838B-856965E8F10F}"/>
              </a:ext>
            </a:extLst>
          </p:cNvPr>
          <p:cNvSpPr txBox="1"/>
          <p:nvPr/>
        </p:nvSpPr>
        <p:spPr>
          <a:xfrm>
            <a:off x="140847" y="3126175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3DEE365E-EEA5-4B54-9CD4-C5C07D18599F}"/>
              </a:ext>
            </a:extLst>
          </p:cNvPr>
          <p:cNvCxnSpPr/>
          <p:nvPr/>
        </p:nvCxnSpPr>
        <p:spPr>
          <a:xfrm>
            <a:off x="394127" y="2724587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E633AAE6-2937-4F1B-A607-2DE6BE831F1A}"/>
              </a:ext>
            </a:extLst>
          </p:cNvPr>
          <p:cNvCxnSpPr/>
          <p:nvPr/>
        </p:nvCxnSpPr>
        <p:spPr>
          <a:xfrm>
            <a:off x="394127" y="3236497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1" name="TextBox 80">
            <a:extLst>
              <a:ext uri="{FF2B5EF4-FFF2-40B4-BE49-F238E27FC236}">
                <a16:creationId xmlns:a16="http://schemas.microsoft.com/office/drawing/2014/main" id="{B1F158D1-78CD-453C-9B0D-DAD768512ADC}"/>
              </a:ext>
            </a:extLst>
          </p:cNvPr>
          <p:cNvSpPr txBox="1"/>
          <p:nvPr/>
        </p:nvSpPr>
        <p:spPr>
          <a:xfrm>
            <a:off x="4780498" y="3984699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F47F5797-FB5A-408F-A669-823E35A7B654}"/>
              </a:ext>
            </a:extLst>
          </p:cNvPr>
          <p:cNvSpPr txBox="1"/>
          <p:nvPr/>
        </p:nvSpPr>
        <p:spPr>
          <a:xfrm>
            <a:off x="7835314" y="2910574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A2D7228F-591B-4455-BEED-F1739DBCE1BB}"/>
              </a:ext>
            </a:extLst>
          </p:cNvPr>
          <p:cNvSpPr txBox="1"/>
          <p:nvPr/>
        </p:nvSpPr>
        <p:spPr>
          <a:xfrm>
            <a:off x="431182" y="3502379"/>
            <a:ext cx="7232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 cells</a:t>
            </a:r>
          </a:p>
        </p:txBody>
      </p:sp>
      <p:pic>
        <p:nvPicPr>
          <p:cNvPr id="71" name="Picture 70">
            <a:extLst>
              <a:ext uri="{FF2B5EF4-FFF2-40B4-BE49-F238E27FC236}">
                <a16:creationId xmlns:a16="http://schemas.microsoft.com/office/drawing/2014/main" id="{B2DE2E4B-C9C7-4674-ACC2-8FF8ACB1B045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" t="-93" r="-360" b="-411"/>
          <a:stretch/>
        </p:blipFill>
        <p:spPr>
          <a:xfrm rot="5400000">
            <a:off x="3638633" y="-8415"/>
            <a:ext cx="1856370" cy="241435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2" name="Picture 71">
            <a:extLst>
              <a:ext uri="{FF2B5EF4-FFF2-40B4-BE49-F238E27FC236}">
                <a16:creationId xmlns:a16="http://schemas.microsoft.com/office/drawing/2014/main" id="{867C5C5E-7C13-45D5-83A7-5946D12F2294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652" t="440" r="657" b="389"/>
          <a:stretch/>
        </p:blipFill>
        <p:spPr>
          <a:xfrm rot="5400000">
            <a:off x="5926292" y="409543"/>
            <a:ext cx="1988450" cy="164903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5" name="Rectangle 74">
            <a:extLst>
              <a:ext uri="{FF2B5EF4-FFF2-40B4-BE49-F238E27FC236}">
                <a16:creationId xmlns:a16="http://schemas.microsoft.com/office/drawing/2014/main" id="{E540BCA3-11F7-4ED6-957A-BB15890BAF38}"/>
              </a:ext>
            </a:extLst>
          </p:cNvPr>
          <p:cNvSpPr/>
          <p:nvPr/>
        </p:nvSpPr>
        <p:spPr>
          <a:xfrm>
            <a:off x="3743238" y="584725"/>
            <a:ext cx="687601" cy="17039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6" name="Rectangle 75">
            <a:extLst>
              <a:ext uri="{FF2B5EF4-FFF2-40B4-BE49-F238E27FC236}">
                <a16:creationId xmlns:a16="http://schemas.microsoft.com/office/drawing/2014/main" id="{7987A85D-1847-4A1C-BACC-A42C1C326DCD}"/>
              </a:ext>
            </a:extLst>
          </p:cNvPr>
          <p:cNvSpPr/>
          <p:nvPr/>
        </p:nvSpPr>
        <p:spPr>
          <a:xfrm>
            <a:off x="6297961" y="728965"/>
            <a:ext cx="936129" cy="17039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36D956B8-858D-4EE7-88C8-DACE26C957E7}"/>
              </a:ext>
            </a:extLst>
          </p:cNvPr>
          <p:cNvSpPr/>
          <p:nvPr/>
        </p:nvSpPr>
        <p:spPr>
          <a:xfrm>
            <a:off x="4640424" y="3702111"/>
            <a:ext cx="830301" cy="17039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8" name="Rectangle 77">
            <a:extLst>
              <a:ext uri="{FF2B5EF4-FFF2-40B4-BE49-F238E27FC236}">
                <a16:creationId xmlns:a16="http://schemas.microsoft.com/office/drawing/2014/main" id="{1F8E30D5-0290-4E57-9C3E-E750E1A14923}"/>
              </a:ext>
            </a:extLst>
          </p:cNvPr>
          <p:cNvSpPr/>
          <p:nvPr/>
        </p:nvSpPr>
        <p:spPr>
          <a:xfrm>
            <a:off x="7690431" y="3178349"/>
            <a:ext cx="830301" cy="17039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F9925C89-6632-4F83-BA87-5708BE50C3A1}"/>
              </a:ext>
            </a:extLst>
          </p:cNvPr>
          <p:cNvSpPr txBox="1"/>
          <p:nvPr/>
        </p:nvSpPr>
        <p:spPr>
          <a:xfrm>
            <a:off x="3786252" y="353893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E8CA1C0B-0060-4688-9D0D-440D31A13EEB}"/>
              </a:ext>
            </a:extLst>
          </p:cNvPr>
          <p:cNvSpPr txBox="1"/>
          <p:nvPr/>
        </p:nvSpPr>
        <p:spPr>
          <a:xfrm>
            <a:off x="6420897" y="483281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</p:spTree>
    <p:extLst>
      <p:ext uri="{BB962C8B-B14F-4D97-AF65-F5344CB8AC3E}">
        <p14:creationId xmlns:p14="http://schemas.microsoft.com/office/powerpoint/2010/main" val="2033256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77</Words>
  <Application>Microsoft Office PowerPoint</Application>
  <PresentationFormat>Widescreen</PresentationFormat>
  <Paragraphs>5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ekle Pauzaite</dc:creator>
  <cp:lastModifiedBy>Tekle Pauzaite</cp:lastModifiedBy>
  <cp:revision>3</cp:revision>
  <dcterms:created xsi:type="dcterms:W3CDTF">2024-03-27T11:01:34Z</dcterms:created>
  <dcterms:modified xsi:type="dcterms:W3CDTF">2024-05-10T10:12:48Z</dcterms:modified>
</cp:coreProperties>
</file>